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84" d="100"/>
          <a:sy n="84" d="100"/>
        </p:scale>
        <p:origin x="16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1C29BCC-3069-4928-96D8-54A1E435B29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41111057-E41A-462D-92A2-D385F75619F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CC34D3A-1385-4414-A730-378B45181D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F08316-855E-4F9A-B9EE-FBC431B12DBC}" type="datetimeFigureOut">
              <a:rPr kumimoji="1" lang="ja-JP" altLang="en-US" smtClean="0"/>
              <a:t>2021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5AE2D80-962B-417E-A72F-8836F81E9A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F7143D3-1419-427A-B09B-D757F5F1C8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C28213-8915-47CF-AF6E-46DF961195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91776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A3472BD-0687-4CB1-A63D-F65515DCD2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56F27BA-CBC2-459E-B764-9E887E816EC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5010885-C5EE-4D61-914A-94DABDDBF5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F08316-855E-4F9A-B9EE-FBC431B12DBC}" type="datetimeFigureOut">
              <a:rPr kumimoji="1" lang="ja-JP" altLang="en-US" smtClean="0"/>
              <a:t>2021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B85F969-67C0-4C3E-B774-26F9EE8B17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A74760A-9709-4B11-A399-FE3B2C3F5E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C28213-8915-47CF-AF6E-46DF961195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0009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4E53FF6B-31A6-47E8-901C-5D14EC9586E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9B935F5-2E13-4BDB-8AE9-EE3DA8681E6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3079FFB-581A-4ED1-A2C3-EC64FC4750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F08316-855E-4F9A-B9EE-FBC431B12DBC}" type="datetimeFigureOut">
              <a:rPr kumimoji="1" lang="ja-JP" altLang="en-US" smtClean="0"/>
              <a:t>2021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1D43D0E-0D93-4F39-B412-F664BB762B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0D210BB-F3BC-4729-B386-29CCD78D46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C28213-8915-47CF-AF6E-46DF961195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27854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72355C3-D319-4EF1-946C-11DB96464A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0FA8FC3-C68E-4110-83EA-6536A96E1A1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FEC0A36-CBC1-4706-83E0-F8C85CC722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F08316-855E-4F9A-B9EE-FBC431B12DBC}" type="datetimeFigureOut">
              <a:rPr kumimoji="1" lang="ja-JP" altLang="en-US" smtClean="0"/>
              <a:t>2021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51D344E-DCF6-460E-B397-6EB9AB703C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102EE39-D2B6-4664-A747-3E37440C3B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C28213-8915-47CF-AF6E-46DF961195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60835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514DC17-A256-4C69-AEE9-D46CEBE3C8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67FA0B3-2DBD-41B2-B3B7-ED164E39FC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CED1E4F-ACBB-40E4-A78C-3129163AC3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F08316-855E-4F9A-B9EE-FBC431B12DBC}" type="datetimeFigureOut">
              <a:rPr kumimoji="1" lang="ja-JP" altLang="en-US" smtClean="0"/>
              <a:t>2021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9ED2ECA-9E3A-44BA-9CF6-B0334E1BE4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6B59AA8-8203-4481-9EA9-8C3167DDC6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C28213-8915-47CF-AF6E-46DF961195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06862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182EF53-C299-40E5-813C-05CA70B920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32B3DA0-E359-4F2E-A46E-32DFCF6282B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9187CEB-AC24-41B0-9BEF-DC6041E9125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571D936-C662-420A-B668-9DB599DD61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F08316-855E-4F9A-B9EE-FBC431B12DBC}" type="datetimeFigureOut">
              <a:rPr kumimoji="1" lang="ja-JP" altLang="en-US" smtClean="0"/>
              <a:t>2021/4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35671C3-34BA-4D6E-BD1B-9EB439F710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CF96904-C66D-4218-8806-DBC2D342AE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C28213-8915-47CF-AF6E-46DF961195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71416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5D8453A-02E2-421B-A0C2-0813A72DB6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F72A6DA-0B5C-4BAE-8E1F-7AEC6A356A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6252AD5-FF38-46CF-9144-06D4365815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9BB82FC8-C804-46EB-BC9D-E12233E320A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34227DD7-77D5-48E1-96A4-BAB8A981509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6E87D750-69BB-46C3-878A-3B3DA55322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F08316-855E-4F9A-B9EE-FBC431B12DBC}" type="datetimeFigureOut">
              <a:rPr kumimoji="1" lang="ja-JP" altLang="en-US" smtClean="0"/>
              <a:t>2021/4/1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E348C1C8-6730-495D-A45B-3FCFE883D9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C49E2BF9-1A44-4483-835F-686BA28FE4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C28213-8915-47CF-AF6E-46DF961195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7957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E538E77-666E-4531-8F38-6E6320EBCD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EA7FECF3-B9C5-4EA2-8C27-FAA6BD455A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F08316-855E-4F9A-B9EE-FBC431B12DBC}" type="datetimeFigureOut">
              <a:rPr kumimoji="1" lang="ja-JP" altLang="en-US" smtClean="0"/>
              <a:t>2021/4/1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8DFE95F0-5386-466F-AFE0-9251D40211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B4879CC2-E66F-4639-AD1E-56D65F65EC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C28213-8915-47CF-AF6E-46DF961195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43455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E33766F2-42E2-48B2-AE0C-994C012DC3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F08316-855E-4F9A-B9EE-FBC431B12DBC}" type="datetimeFigureOut">
              <a:rPr kumimoji="1" lang="ja-JP" altLang="en-US" smtClean="0"/>
              <a:t>2021/4/1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230DD424-2A38-4DE1-8085-350540DEF0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5D0A53AE-4149-45B7-B083-55C70920F1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C28213-8915-47CF-AF6E-46DF961195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35947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4EB8017-CC51-4736-A718-3F793D7F35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BFF5362-3D83-4F76-A00E-88CAD611EA0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FFB65F8-5CAE-426B-9E75-3BF0B1AF764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A51F5F5-8E7B-40AD-9FA4-5A4BBCCA4F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F08316-855E-4F9A-B9EE-FBC431B12DBC}" type="datetimeFigureOut">
              <a:rPr kumimoji="1" lang="ja-JP" altLang="en-US" smtClean="0"/>
              <a:t>2021/4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50D8CB5-8919-4FFC-BD34-B738594B7D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393809E-35C9-4B09-BFE8-B81C4D3C23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C28213-8915-47CF-AF6E-46DF961195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90544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3F43991-ECD0-48C6-BBE4-22E1A1D60B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57F68F22-AAFC-4D90-9B60-AA8C876C657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3B15FD4-52F9-44C2-B86C-86B1644889C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184E1D4-B741-4C16-A350-7816CEEE2C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F08316-855E-4F9A-B9EE-FBC431B12DBC}" type="datetimeFigureOut">
              <a:rPr kumimoji="1" lang="ja-JP" altLang="en-US" smtClean="0"/>
              <a:t>2021/4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7D8EBE0-B1AA-4AB2-8154-1B028DB764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DDAD3C9-6FA7-4B4B-A8EE-9D30B4FE3D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C28213-8915-47CF-AF6E-46DF961195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9936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E0AA7DC2-3F4C-4B43-903B-979FC8F4F2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50C2DA5-E6E8-4E9F-A408-0028057C6C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FB1DED1-E485-4514-8949-1E65CABCB0B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F08316-855E-4F9A-B9EE-FBC431B12DBC}" type="datetimeFigureOut">
              <a:rPr kumimoji="1" lang="ja-JP" altLang="en-US" smtClean="0"/>
              <a:t>2021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05332A9-DA4F-462E-A14C-F2B1598DADE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77AD349-D79E-4936-B74C-CD69EBA7AA8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C28213-8915-47CF-AF6E-46DF961195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97788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4CE4E1C0-63E2-4DBE-AA4A-D0D664200B8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9208" y="662605"/>
            <a:ext cx="3305193" cy="4777142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8B86248-FAA0-49EF-B596-7FA267913214}"/>
              </a:ext>
            </a:extLst>
          </p:cNvPr>
          <p:cNvSpPr txBox="1"/>
          <p:nvPr/>
        </p:nvSpPr>
        <p:spPr>
          <a:xfrm>
            <a:off x="429208" y="223935"/>
            <a:ext cx="19543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gure 1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45AD20E7-257A-42E9-8489-6D9FBFE263B5}"/>
              </a:ext>
            </a:extLst>
          </p:cNvPr>
          <p:cNvSpPr txBox="1"/>
          <p:nvPr/>
        </p:nvSpPr>
        <p:spPr>
          <a:xfrm>
            <a:off x="587829" y="5794310"/>
            <a:ext cx="911018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ゴシック" panose="020B0400000000000000" pitchFamily="50" charset="-128"/>
              </a:rPr>
              <a:t>Average number of procedures per department per year of 74 hospitals. </a:t>
            </a:r>
          </a:p>
          <a:p>
            <a:r>
              <a:rPr lang="en-US" altLang="ja-JP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ゴシック" panose="020B0400000000000000" pitchFamily="50" charset="-128"/>
              </a:rPr>
              <a:t>The axis shows the number of procedures and the horizontal axis shows the number of hospitals.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4672002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32</Words>
  <Application>Microsoft Office PowerPoint</Application>
  <PresentationFormat>ワイド画面</PresentationFormat>
  <Paragraphs>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梶原 俊毅</dc:creator>
  <cp:lastModifiedBy>梶原 俊毅</cp:lastModifiedBy>
  <cp:revision>3</cp:revision>
  <dcterms:created xsi:type="dcterms:W3CDTF">2021-01-26T04:18:13Z</dcterms:created>
  <dcterms:modified xsi:type="dcterms:W3CDTF">2021-04-12T10:43:04Z</dcterms:modified>
</cp:coreProperties>
</file>